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B7B0955-F995-40CC-94C6-045A9EA7E8E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514440" y="264168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37DE701-D94B-4EA0-BE16-DB066931FC3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42E991E-E82F-40C4-8FA1-C0406350D0A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514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2485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445608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514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2485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445608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5F01D4D-4AC7-42C1-9EF4-19E41A3D012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514440" y="2641680"/>
            <a:ext cx="5829120" cy="54864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8BE9777-87AE-497D-A941-EEDDCB5D0BA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514440" y="2641680"/>
            <a:ext cx="582912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8164F11-C68D-4284-9794-0785A167F72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857EA8D-2126-49BC-8154-2E6A0341145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B6DF9AE-0FA0-4920-BC6A-A111CE7F2C6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14440" y="812520"/>
            <a:ext cx="582912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2D6B29D-FD15-4825-9DB0-F0A97E21031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8F1CFF7-9A18-4B16-825D-C0590215ED0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5AA3CC6-81E0-4F66-9617-D9EA16BF6AA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743B15C-3EA5-4EB7-83EA-2D1EF60C869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514440" y="2641680"/>
            <a:ext cx="5829120" cy="5486400"/>
          </a:xfrm>
          <a:prstGeom prst="rect">
            <a:avLst/>
          </a:prstGeom>
          <a:noFill/>
          <a:ln w="0">
            <a:noFill/>
          </a:ln>
        </p:spPr>
        <p:txBody>
          <a:bodyPr lIns="90000" rIns="90000" tIns="46800" bIns="46800" anchor="t">
            <a:normAutofit/>
          </a:bodyPr>
          <a:p>
            <a:pPr marL="343080" indent="-343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43040" indent="-28584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430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6002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514080" y="8331120"/>
            <a:ext cx="1428840" cy="6098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2343240" y="8331120"/>
            <a:ext cx="2171520" cy="6098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4915080" y="8331120"/>
            <a:ext cx="1428480" cy="6098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F151EA4-905B-4712-B939-F6DDD5180E9E}"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tretch/>
        </p:blipFill>
        <p:spPr>
          <a:xfrm>
            <a:off x="990720" y="1143000"/>
            <a:ext cx="4379760" cy="7848720"/>
          </a:xfrm>
          <a:prstGeom prst="rect">
            <a:avLst/>
          </a:prstGeom>
          <a:ln w="0">
            <a:noFill/>
          </a:ln>
        </p:spPr>
      </p:pic>
      <p:sp>
        <p:nvSpPr>
          <p:cNvPr id="42" name=""/>
          <p:cNvSpPr/>
          <p:nvPr/>
        </p:nvSpPr>
        <p:spPr>
          <a:xfrm>
            <a:off x="228600" y="228600"/>
            <a:ext cx="6248520" cy="91440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8) Bin size exploration: </a:t>
            </a:r>
            <a:r>
              <a:rPr b="0" lang="en-US" sz="1200" spc="-1" strike="noStrike">
                <a:solidFill>
                  <a:srgbClr val="000000"/>
                </a:solidFill>
                <a:latin typeface="Arial"/>
              </a:rPr>
              <a:t>the figure below shows the effect of using different bin sizes to calculate neuronal ensemble correlations. We observed quantitative differences (the larger the bin size, the larger the correlations), but qualitatively the correlations profiles are equivalent, i.e. have very similar shapes.</a:t>
            </a:r>
            <a:endParaRPr b="0"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11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3-03-27T01:46:11Z</dcterms:created>
  <dc:creator>Sidarta Ribeiro</dc:creator>
  <dc:description/>
  <dc:language>en-US</dc:language>
  <cp:lastModifiedBy>Liana Holmberg</cp:lastModifiedBy>
  <dcterms:modified xsi:type="dcterms:W3CDTF">2003-12-05T00:13:20Z</dcterms:modified>
  <cp:revision>86</cp:revision>
  <dc:subject/>
  <dc:title>Supplementary Material</dc:title>
</cp:coreProperties>
</file>